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80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59506A-30EB-1830-F77B-013FF8E7D4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9F53FFB-8E9E-7737-CD05-DDADFD3657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636E96-4B1A-B651-0A6C-174F940247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EA821C-7397-805A-F7C4-FC94506DE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FFE57B-59E8-1686-5AD9-5C77E1CCA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7296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328604-B920-63BA-18A0-4CE6561E6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D5C78DF-5127-B775-0DE3-9BFF2372EC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AF023A-3FB8-E7C1-719A-80AF15337A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FD3DA0B-A230-2231-BD13-09322BC0F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F85E38-D945-12E4-A154-95CF88A5B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434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298EC43-952E-3181-F937-A7545743D9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DE11B82-444F-7F50-A022-FBFD7E3186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952BAB-7B21-8ACE-C992-9C7F3B5BF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7AB759-F743-B5A3-82CB-38C24E2721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6C84FD-789B-14D0-59AC-279C862CE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3147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6F60BF-C141-6770-1B2E-76E764B391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34F0FED-C8C5-798E-D958-AE41B3FDB3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D2FEA0-E642-D0E7-A8F8-81CB3AA23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86B4A0-34C6-B3A9-A4B7-F398E40B3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0C8C26-6C6F-BF84-470C-4749A2154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091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19307A-A060-20C7-D691-F421617737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2F0EDE-3AC3-2A52-A02F-89EAD42C0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E50251-E6D2-9A91-D453-6510249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B11E32-5225-A7EB-7B7B-DC1436038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FDB7D5-6989-CA53-2AEB-8409E61D9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375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DC3E2A-3FD7-584B-21E3-20987E1EC7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FC603F-078F-D848-5E84-6138F4FBFA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A09738-829F-1A04-14AB-272709CDF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8CF8444-669B-FC39-60F1-BC98AD918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D13C82-38A1-75B5-E2A5-2DC483CFA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933C76-17F2-0703-D44B-CE5B0C8F9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6144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0F2B50-8E35-E4E5-4C3D-7270C5829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E29744-3DB9-88F4-20B1-5B5CC2576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1A626A0-D46F-0B9A-62E4-1D695C9B25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6B7435B-2342-1890-26FB-0D9EA05497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F7031EB-D21C-6F08-A65B-D4DFEB5C87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5FDED35-5F7D-984E-072A-E32967394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31C2689-A9BB-D6AF-4B7C-DA7D04D65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E192ABF-5813-6496-1B0B-3B5E35404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1241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05B732-68E6-D0A8-D28B-6FE9D74289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00DBBC3-C7BC-265F-17A2-C2C946E22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B85323B-915E-6504-9A30-4778DF541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59CE3C3-378D-F924-E0E0-3FAD8F763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709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17FDECF-DF34-1498-6B87-DE2C2E72DA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8086970-5BD9-11D0-2BEF-B0B3D5090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D91C47C-8E56-6F42-C47F-446EE5BD9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1185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AFB21F-971E-2F0A-917A-68E53353B7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F3A539-D6E2-CC18-7827-70034135A0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91F037E-909B-FF46-9816-DE8E287365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716EF35-33CC-19C8-2C89-0B8B6AB41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82A68D-B360-D890-45EB-D164472C7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7E69795-B19D-7767-254C-019A1722D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068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C8766E-C3D7-5969-0896-AA08A099D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24B8723-0A32-C253-55DE-1FC598B084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25DD4D-8D9D-1760-817C-BBA9BAC527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F786F4-4B98-3B7A-8356-ED5267DCE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41EBE9-D39B-37F5-4AA0-C69D0E6D6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4C1C1A-22E6-BFB8-B860-3D3517576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430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B76A1A8-A793-D5D2-B613-DB7B8A2694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FD7A001-BD93-2406-DCBF-7804D474B4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E91680-5A46-BB43-A543-5698DE60C92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4E445-4872-4D59-B11F-9CEBDDC3D8CD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EB8DA6-72E7-A0BF-6E02-14AC864D70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E4D06A-F0B2-FE95-78B6-A6C885A42E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3B01E-1C06-416F-AA8A-98B5C03B38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984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4167C-8015-4B6C-3D4F-FD316DFE48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199A50A-305D-1132-4018-771AC4ADA4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99957">
            <a:off x="0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B4662A59-0F86-2689-9D6B-7CCE806640D4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B4FC3B-1704-7B96-9695-7D3B70E1DFE6}"/>
              </a:ext>
            </a:extLst>
          </p:cNvPr>
          <p:cNvSpPr txBox="1"/>
          <p:nvPr/>
        </p:nvSpPr>
        <p:spPr>
          <a:xfrm rot="19189580">
            <a:off x="3646627" y="2312684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2834037-06C9-3E48-B0DC-9E57C0BF4572}"/>
              </a:ext>
            </a:extLst>
          </p:cNvPr>
          <p:cNvSpPr txBox="1"/>
          <p:nvPr/>
        </p:nvSpPr>
        <p:spPr>
          <a:xfrm rot="19189580">
            <a:off x="4132535" y="240782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A3D7306-69A9-7AEF-EBD4-66A028255A6B}"/>
              </a:ext>
            </a:extLst>
          </p:cNvPr>
          <p:cNvCxnSpPr>
            <a:cxnSpLocks/>
          </p:cNvCxnSpPr>
          <p:nvPr/>
        </p:nvCxnSpPr>
        <p:spPr>
          <a:xfrm>
            <a:off x="6232833" y="4122712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B8B5D2-9976-1DC7-2AC4-67CB6F995324}"/>
              </a:ext>
            </a:extLst>
          </p:cNvPr>
          <p:cNvSpPr txBox="1"/>
          <p:nvPr/>
        </p:nvSpPr>
        <p:spPr>
          <a:xfrm>
            <a:off x="246185" y="246185"/>
            <a:ext cx="9621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α-sub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153A2FF-738E-723E-CBD4-D15EBA4EB20B}"/>
              </a:ext>
            </a:extLst>
          </p:cNvPr>
          <p:cNvSpPr txBox="1"/>
          <p:nvPr/>
        </p:nvSpPr>
        <p:spPr>
          <a:xfrm>
            <a:off x="6340100" y="395565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0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FB06DF3-1994-4341-E34C-115AE58FD91B}"/>
              </a:ext>
            </a:extLst>
          </p:cNvPr>
          <p:cNvCxnSpPr>
            <a:cxnSpLocks/>
          </p:cNvCxnSpPr>
          <p:nvPr/>
        </p:nvCxnSpPr>
        <p:spPr>
          <a:xfrm>
            <a:off x="6232833" y="3899192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C731292-E243-9AFA-9210-11EEF68C906A}"/>
              </a:ext>
            </a:extLst>
          </p:cNvPr>
          <p:cNvSpPr txBox="1"/>
          <p:nvPr/>
        </p:nvSpPr>
        <p:spPr>
          <a:xfrm>
            <a:off x="6340100" y="373213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5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CA37004-96E3-DAAC-64F5-E3B1EF705EBE}"/>
              </a:ext>
            </a:extLst>
          </p:cNvPr>
          <p:cNvCxnSpPr>
            <a:cxnSpLocks/>
          </p:cNvCxnSpPr>
          <p:nvPr/>
        </p:nvCxnSpPr>
        <p:spPr>
          <a:xfrm>
            <a:off x="6232833" y="3403892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14B17E8F-E70D-F0D8-56EE-2740E7B1B8C4}"/>
              </a:ext>
            </a:extLst>
          </p:cNvPr>
          <p:cNvSpPr txBox="1"/>
          <p:nvPr/>
        </p:nvSpPr>
        <p:spPr>
          <a:xfrm>
            <a:off x="6340100" y="323683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75B70B6-7833-7F46-3817-39551BC88BCC}"/>
              </a:ext>
            </a:extLst>
          </p:cNvPr>
          <p:cNvSpPr/>
          <p:nvPr/>
        </p:nvSpPr>
        <p:spPr>
          <a:xfrm>
            <a:off x="3525520" y="3307276"/>
            <a:ext cx="2245360" cy="5179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6103323-3FAF-D2F3-3C68-93DB61D268F1}"/>
              </a:ext>
            </a:extLst>
          </p:cNvPr>
          <p:cNvSpPr txBox="1"/>
          <p:nvPr/>
        </p:nvSpPr>
        <p:spPr>
          <a:xfrm rot="19189580">
            <a:off x="4609422" y="2282385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95E3C1F-8779-2A50-0D9B-9EC7FCFE3620}"/>
              </a:ext>
            </a:extLst>
          </p:cNvPr>
          <p:cNvSpPr txBox="1"/>
          <p:nvPr/>
        </p:nvSpPr>
        <p:spPr>
          <a:xfrm rot="19189580">
            <a:off x="5141564" y="2377523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928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68CF63-C9C8-E5D5-98FD-DCAF3066DE4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D975E954-3A2B-E177-6DD4-1C40B5D461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66E43A3B-632F-8DED-759B-40810C748A8F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8C47F80-F0FA-16BE-218E-C75C7FC52281}"/>
              </a:ext>
            </a:extLst>
          </p:cNvPr>
          <p:cNvSpPr txBox="1"/>
          <p:nvPr/>
        </p:nvSpPr>
        <p:spPr>
          <a:xfrm>
            <a:off x="246185" y="246185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PSMC2</a:t>
            </a:r>
            <a:endParaRPr lang="zh-CN" altLang="en-US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93D342C9-AC9D-7AA4-F866-B1F5DF1463EE}"/>
              </a:ext>
            </a:extLst>
          </p:cNvPr>
          <p:cNvCxnSpPr>
            <a:cxnSpLocks/>
          </p:cNvCxnSpPr>
          <p:nvPr/>
        </p:nvCxnSpPr>
        <p:spPr>
          <a:xfrm>
            <a:off x="4536440" y="36957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6DB6E83A-1989-C8A9-076F-71A4D23D1A11}"/>
              </a:ext>
            </a:extLst>
          </p:cNvPr>
          <p:cNvSpPr txBox="1"/>
          <p:nvPr/>
        </p:nvSpPr>
        <p:spPr>
          <a:xfrm>
            <a:off x="4643707" y="352864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A6277A10-72E3-393B-07F5-18AFFB1407EE}"/>
              </a:ext>
            </a:extLst>
          </p:cNvPr>
          <p:cNvSpPr/>
          <p:nvPr/>
        </p:nvSpPr>
        <p:spPr>
          <a:xfrm>
            <a:off x="2377440" y="3286956"/>
            <a:ext cx="2133600" cy="5179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20792A6-AD1C-9220-1FA0-7B750D66DCE6}"/>
              </a:ext>
            </a:extLst>
          </p:cNvPr>
          <p:cNvSpPr txBox="1"/>
          <p:nvPr/>
        </p:nvSpPr>
        <p:spPr>
          <a:xfrm rot="19189580">
            <a:off x="2439154" y="2664374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9099F07-3540-D722-F7F7-128A55B68A1B}"/>
              </a:ext>
            </a:extLst>
          </p:cNvPr>
          <p:cNvSpPr txBox="1"/>
          <p:nvPr/>
        </p:nvSpPr>
        <p:spPr>
          <a:xfrm rot="19189580">
            <a:off x="2925062" y="275951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4408485-CDB1-03C6-E727-94B7AD6E8F6E}"/>
              </a:ext>
            </a:extLst>
          </p:cNvPr>
          <p:cNvSpPr txBox="1"/>
          <p:nvPr/>
        </p:nvSpPr>
        <p:spPr>
          <a:xfrm rot="19189580">
            <a:off x="3401949" y="2634075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B710C93-C50F-49B9-5260-BC726AEF0B66}"/>
              </a:ext>
            </a:extLst>
          </p:cNvPr>
          <p:cNvSpPr txBox="1"/>
          <p:nvPr/>
        </p:nvSpPr>
        <p:spPr>
          <a:xfrm rot="19189580">
            <a:off x="3934091" y="2729213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98879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915DD8-B6B4-9F30-B8BF-3B29BE2CBFA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F6C24E85-7998-0CBC-EF36-7DF907473E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66652">
            <a:off x="-1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614378C0-5821-6A0C-F1DD-F2432F566246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C6ED14C2-7BBE-E376-33FD-6EF49C87BF37}"/>
              </a:ext>
            </a:extLst>
          </p:cNvPr>
          <p:cNvCxnSpPr>
            <a:cxnSpLocks/>
          </p:cNvCxnSpPr>
          <p:nvPr/>
        </p:nvCxnSpPr>
        <p:spPr>
          <a:xfrm>
            <a:off x="4777740" y="375666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14F3D216-73AA-86F2-3060-FD3ED0B59F18}"/>
              </a:ext>
            </a:extLst>
          </p:cNvPr>
          <p:cNvSpPr txBox="1"/>
          <p:nvPr/>
        </p:nvSpPr>
        <p:spPr>
          <a:xfrm>
            <a:off x="246185" y="246185"/>
            <a:ext cx="12282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PSMA7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B952ABF-4912-6BE1-B0DD-0EB90730114D}"/>
              </a:ext>
            </a:extLst>
          </p:cNvPr>
          <p:cNvSpPr txBox="1"/>
          <p:nvPr/>
        </p:nvSpPr>
        <p:spPr>
          <a:xfrm>
            <a:off x="4885007" y="358960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5E1B420D-386F-98B5-B52D-7134A2A28209}"/>
              </a:ext>
            </a:extLst>
          </p:cNvPr>
          <p:cNvCxnSpPr>
            <a:cxnSpLocks/>
          </p:cNvCxnSpPr>
          <p:nvPr/>
        </p:nvCxnSpPr>
        <p:spPr>
          <a:xfrm>
            <a:off x="4770120" y="330708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FC904F5-AE7C-E294-6B8C-6A35D318FC6B}"/>
              </a:ext>
            </a:extLst>
          </p:cNvPr>
          <p:cNvSpPr txBox="1"/>
          <p:nvPr/>
        </p:nvSpPr>
        <p:spPr>
          <a:xfrm>
            <a:off x="4877387" y="314002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5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A0882F43-5F50-DA09-C861-D6933D966D52}"/>
              </a:ext>
            </a:extLst>
          </p:cNvPr>
          <p:cNvSpPr/>
          <p:nvPr/>
        </p:nvSpPr>
        <p:spPr>
          <a:xfrm>
            <a:off x="2372360" y="3009320"/>
            <a:ext cx="2230120" cy="4196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BF3C646-B5FA-356C-BFAE-1D8FB8FC12D3}"/>
              </a:ext>
            </a:extLst>
          </p:cNvPr>
          <p:cNvSpPr txBox="1"/>
          <p:nvPr/>
        </p:nvSpPr>
        <p:spPr>
          <a:xfrm rot="19189580">
            <a:off x="2466010" y="2266384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09ABCB0-7103-9483-7097-9D847F9E3D54}"/>
              </a:ext>
            </a:extLst>
          </p:cNvPr>
          <p:cNvSpPr txBox="1"/>
          <p:nvPr/>
        </p:nvSpPr>
        <p:spPr>
          <a:xfrm rot="19189580">
            <a:off x="2951918" y="2361522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B0FCF15-E646-E2C3-1CE1-691700576BBA}"/>
              </a:ext>
            </a:extLst>
          </p:cNvPr>
          <p:cNvSpPr txBox="1"/>
          <p:nvPr/>
        </p:nvSpPr>
        <p:spPr>
          <a:xfrm rot="19189580">
            <a:off x="3428805" y="2236085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1CD45D7-0AC1-97C4-F2A4-92040C920658}"/>
              </a:ext>
            </a:extLst>
          </p:cNvPr>
          <p:cNvSpPr txBox="1"/>
          <p:nvPr/>
        </p:nvSpPr>
        <p:spPr>
          <a:xfrm rot="19189580">
            <a:off x="3960947" y="2331223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93A35F62-64AE-C7F5-0EA7-78213244EDC0}"/>
              </a:ext>
            </a:extLst>
          </p:cNvPr>
          <p:cNvCxnSpPr>
            <a:cxnSpLocks/>
          </p:cNvCxnSpPr>
          <p:nvPr/>
        </p:nvCxnSpPr>
        <p:spPr>
          <a:xfrm>
            <a:off x="4757928" y="28956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D910773E-8521-FAA7-1D01-36178FD9F4C3}"/>
              </a:ext>
            </a:extLst>
          </p:cNvPr>
          <p:cNvSpPr txBox="1"/>
          <p:nvPr/>
        </p:nvSpPr>
        <p:spPr>
          <a:xfrm>
            <a:off x="4865195" y="272854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40724459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F7AAEFF-FD1B-7384-FE42-6799B049F6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AEA50AA2-7586-80D0-394C-FCD1AF776268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386F1C9-4AA3-E2F2-C7FD-4EE13F7C3BC0}"/>
              </a:ext>
            </a:extLst>
          </p:cNvPr>
          <p:cNvSpPr txBox="1"/>
          <p:nvPr/>
        </p:nvSpPr>
        <p:spPr>
          <a:xfrm>
            <a:off x="246185" y="246185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DDB1</a:t>
            </a:r>
            <a:endParaRPr lang="zh-CN" altLang="en-US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B1F3BDC0-2925-816E-6D3B-565E52F89C66}"/>
              </a:ext>
            </a:extLst>
          </p:cNvPr>
          <p:cNvCxnSpPr>
            <a:cxnSpLocks/>
          </p:cNvCxnSpPr>
          <p:nvPr/>
        </p:nvCxnSpPr>
        <p:spPr>
          <a:xfrm>
            <a:off x="5074920" y="40259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41DC0459-A9E5-26B2-C853-834D61175B52}"/>
              </a:ext>
            </a:extLst>
          </p:cNvPr>
          <p:cNvSpPr txBox="1"/>
          <p:nvPr/>
        </p:nvSpPr>
        <p:spPr>
          <a:xfrm>
            <a:off x="5182187" y="385884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0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F38E0174-81AC-9BD8-C13B-8FA2F18C7134}"/>
              </a:ext>
            </a:extLst>
          </p:cNvPr>
          <p:cNvCxnSpPr>
            <a:cxnSpLocks/>
          </p:cNvCxnSpPr>
          <p:nvPr/>
        </p:nvCxnSpPr>
        <p:spPr>
          <a:xfrm>
            <a:off x="5074920" y="378587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42A5D1E0-1EDE-73FE-924A-A54025CB6E7F}"/>
              </a:ext>
            </a:extLst>
          </p:cNvPr>
          <p:cNvSpPr txBox="1"/>
          <p:nvPr/>
        </p:nvSpPr>
        <p:spPr>
          <a:xfrm>
            <a:off x="5182187" y="361881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50</a:t>
            </a:r>
            <a:endParaRPr lang="zh-CN" altLang="en-US" sz="1600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E4C3586B-8DE2-4D3F-1F49-4AAD0BD94529}"/>
              </a:ext>
            </a:extLst>
          </p:cNvPr>
          <p:cNvCxnSpPr>
            <a:cxnSpLocks/>
          </p:cNvCxnSpPr>
          <p:nvPr/>
        </p:nvCxnSpPr>
        <p:spPr>
          <a:xfrm>
            <a:off x="5074920" y="353314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59BA8037-6FC0-0B1E-672A-A491343CCCA3}"/>
              </a:ext>
            </a:extLst>
          </p:cNvPr>
          <p:cNvSpPr txBox="1"/>
          <p:nvPr/>
        </p:nvSpPr>
        <p:spPr>
          <a:xfrm>
            <a:off x="5182187" y="336608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50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DF5CC6B-2202-788A-DF91-88A7AC66D3F8}"/>
              </a:ext>
            </a:extLst>
          </p:cNvPr>
          <p:cNvSpPr/>
          <p:nvPr/>
        </p:nvSpPr>
        <p:spPr>
          <a:xfrm>
            <a:off x="2992120" y="3686523"/>
            <a:ext cx="2047240" cy="4094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D8C3EAF0-AF7E-1302-8EF5-7C8E755BEF14}"/>
              </a:ext>
            </a:extLst>
          </p:cNvPr>
          <p:cNvSpPr txBox="1"/>
          <p:nvPr/>
        </p:nvSpPr>
        <p:spPr>
          <a:xfrm rot="19189580">
            <a:off x="3016994" y="2435859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4E0224E-50F4-76B6-2FD1-12C326F6977C}"/>
              </a:ext>
            </a:extLst>
          </p:cNvPr>
          <p:cNvSpPr txBox="1"/>
          <p:nvPr/>
        </p:nvSpPr>
        <p:spPr>
          <a:xfrm rot="19189580">
            <a:off x="3502902" y="2530997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3254F1E-FAB0-03CE-0801-EC1605F27CA9}"/>
              </a:ext>
            </a:extLst>
          </p:cNvPr>
          <p:cNvSpPr txBox="1"/>
          <p:nvPr/>
        </p:nvSpPr>
        <p:spPr>
          <a:xfrm rot="19189580">
            <a:off x="3979789" y="2405560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FA2E5E1-062A-6765-B936-769000BCA153}"/>
              </a:ext>
            </a:extLst>
          </p:cNvPr>
          <p:cNvSpPr txBox="1"/>
          <p:nvPr/>
        </p:nvSpPr>
        <p:spPr>
          <a:xfrm rot="19189580">
            <a:off x="4511931" y="250069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3037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06</Words>
  <Application>Microsoft Office PowerPoint</Application>
  <PresentationFormat>宽屏</PresentationFormat>
  <Paragraphs>34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 Rong</dc:creator>
  <cp:lastModifiedBy>yan Rong</cp:lastModifiedBy>
  <cp:revision>10</cp:revision>
  <dcterms:created xsi:type="dcterms:W3CDTF">2026-03-07T08:43:38Z</dcterms:created>
  <dcterms:modified xsi:type="dcterms:W3CDTF">2026-03-08T03:43:00Z</dcterms:modified>
</cp:coreProperties>
</file>